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21BCA3-9451-4B12-A9D7-04222C6CEF6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221740-C57F-4B69-BEAB-74B8BE48F4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2CDEB-A53D-4FC7-AE8E-2091DD184F1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11686-9EE3-418F-B39A-5551B9B563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A0E567-B505-480F-A81E-80C3DBEBC6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7A459D-9CE7-479B-B920-4A6048A589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2FC753-A36D-457D-A24F-8849F3BD5F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5BA3DA-F73E-4D1B-A13E-E1CF04DDEA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D4794E-9FFA-45C8-93C3-BF5DD383CE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9FE6FB-A094-4D2E-803D-B0941A2EAD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B914EE-48CF-415D-AE5A-C46FC3B2EB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9F8F20-077C-4DD0-AA47-856E57151A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400" spc="-1" strike="noStrike">
                <a:solidFill>
                  <a:srgbClr val="000000"/>
                </a:solidFill>
                <a:latin typeface="굴림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400" spc="-1" strike="noStrike">
                <a:solidFill>
                  <a:srgbClr val="000000"/>
                </a:solidFill>
                <a:latin typeface="굴림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AA6DDE-2358-4F8E-8F65-4DD2A026ADFA}" type="slidenum">
              <a:rPr b="0" lang="ko-KR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"/>
          <p:cNvSpPr/>
          <p:nvPr/>
        </p:nvSpPr>
        <p:spPr>
          <a:xfrm>
            <a:off x="104040" y="0"/>
            <a:ext cx="2504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Supplemental Table 5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476360" y="1285920"/>
          <a:ext cx="6121440" cy="4648320"/>
        </p:xfrm>
        <a:graphic>
          <a:graphicData uri="http://schemas.openxmlformats.org/drawingml/2006/table">
            <a:tbl>
              <a:tblPr/>
              <a:tblGrid>
                <a:gridCol w="1008000"/>
                <a:gridCol w="2305080"/>
                <a:gridCol w="792360"/>
                <a:gridCol w="863280"/>
                <a:gridCol w="1152720"/>
              </a:tblGrid>
              <a:tr h="28728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 I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erm descrip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opulation cou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tudy cou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18000" bIns="1800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justed </a:t>
                      </a:r>
                      <a:r>
                        <a:rPr b="1" i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-valu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728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iological Proces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7110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NA conformation change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2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96E-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76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1604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ular component organiza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8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9E-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0704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 cycle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2E-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4408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ular component biogenesis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97E-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2303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racellular signaling pathway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8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8E-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650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-DNA complex assembl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1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0633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omatin assembly or disassembl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1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5130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 division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2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76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068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itrogen compound metabolic proces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5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31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4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5127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omosome organiza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1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4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0815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tabolic process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2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8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22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76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0998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ular process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5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9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4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06259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NA metabolic proces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117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76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3250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evelopmental proces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275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4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485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ositive regulation of biological process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34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728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ellular componen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0562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racellular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14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7E-1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432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rganelle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93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6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8E-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0569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hromoso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11E-1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3299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-DNA complex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01E-1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76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0563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ucleu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9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5E-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310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xtracellular matrix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7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6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O:0032991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acromolecular complex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9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9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lecular Func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GO:000367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nucleic acid bindin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182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15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6.64E-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04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GO:000548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binding*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799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4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4.78E-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40400"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GO:003052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transcription regulator activity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89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6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8000" rIns="18000" tIns="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0.0025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18000" marR="18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 Box 228"/>
          <p:cNvSpPr/>
          <p:nvPr/>
        </p:nvSpPr>
        <p:spPr>
          <a:xfrm>
            <a:off x="735120" y="907920"/>
            <a:ext cx="7653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000000"/>
                </a:solidFill>
                <a:latin typeface="Times New Roman"/>
              </a:rPr>
              <a:t>Table S5. Over-represented gene ontology categories of the down-regulated genes in MG132 treated RIF-1 cells.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직사각형 5"/>
          <p:cNvSpPr/>
          <p:nvPr/>
        </p:nvSpPr>
        <p:spPr>
          <a:xfrm>
            <a:off x="1450800" y="5962680"/>
            <a:ext cx="6240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*Common categories of down-regulated genes in heat shock and MG132 treated RIF-1 cells. 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4T01:52:06Z</dcterms:created>
  <dc:creator>김희정</dc:creator>
  <dc:description/>
  <dc:language>en-US</dc:language>
  <cp:lastModifiedBy>김희정</cp:lastModifiedBy>
  <dcterms:modified xsi:type="dcterms:W3CDTF">2011-06-14T01:52:13Z</dcterms:modified>
  <cp:revision>1</cp:revision>
  <dc:subject/>
  <dc:title>슬라이드 1</dc:title>
</cp:coreProperties>
</file>